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00B0F0"/>
    <a:srgbClr val="AA0065"/>
    <a:srgbClr val="0092F7"/>
    <a:srgbClr val="65AA00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4/05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rterial Stiffness and Blood Pressure Increase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 Pediatric Kidney Transplant Recipient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203305"/>
            <a:ext cx="1201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Arterial stiffness increases after transplantation and is strongly associated with changes in blood pressur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ugianto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" y="5764242"/>
            <a:ext cx="7628462" cy="990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  <a:spcBef>
                <a:spcPts val="600"/>
              </a:spcBef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S</a:t>
            </a:r>
            <a:r>
              <a:rPr lang="en-GB" dirty="0">
                <a:solidFill>
                  <a:schemeClr val="bg1"/>
                </a:solidFill>
              </a:rPr>
              <a:t>:</a:t>
            </a:r>
          </a:p>
          <a:p>
            <a:pPr marL="119063" indent="-119063">
              <a:lnSpc>
                <a:spcPts val="1500"/>
              </a:lnSpc>
              <a:spcBef>
                <a:spcPts val="600"/>
              </a:spcBef>
              <a:spcAft>
                <a:spcPts val="600"/>
              </a:spcAft>
              <a:buFont typeface="Wingdings" panose="05000000000000000000" pitchFamily="2" charset="2"/>
              <a:buChar char="§"/>
            </a:pPr>
            <a:r>
              <a:rPr lang="en-GB" dirty="0">
                <a:solidFill>
                  <a:schemeClr val="bg1"/>
                </a:solidFill>
              </a:rPr>
              <a:t>Arterial stiffness increases after transplantation.</a:t>
            </a:r>
          </a:p>
          <a:p>
            <a:pPr marL="119063" indent="-119063">
              <a:lnSpc>
                <a:spcPts val="1500"/>
              </a:lnSpc>
              <a:spcBef>
                <a:spcPts val="600"/>
              </a:spcBef>
              <a:spcAft>
                <a:spcPts val="600"/>
              </a:spcAft>
              <a:buFont typeface="Wingdings" panose="05000000000000000000" pitchFamily="2" charset="2"/>
              <a:buChar char="§"/>
            </a:pPr>
            <a:r>
              <a:rPr lang="en-GB" dirty="0">
                <a:solidFill>
                  <a:schemeClr val="bg1"/>
                </a:solidFill>
              </a:rPr>
              <a:t>The increase is strongly associated with higher BP values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017310" y="3153298"/>
            <a:ext cx="619229" cy="667367"/>
            <a:chOff x="440265" y="2608627"/>
            <a:chExt cx="619229" cy="667367"/>
          </a:xfrm>
        </p:grpSpPr>
        <p:sp>
          <p:nvSpPr>
            <p:cNvPr id="11" name="Freeform 10"/>
            <p:cNvSpPr>
              <a:spLocks noChangeAspect="1"/>
            </p:cNvSpPr>
            <p:nvPr/>
          </p:nvSpPr>
          <p:spPr>
            <a:xfrm>
              <a:off x="440265" y="2608628"/>
              <a:ext cx="437853" cy="667366"/>
            </a:xfrm>
            <a:custGeom>
              <a:avLst/>
              <a:gdLst>
                <a:gd name="connsiteX0" fmla="*/ 667879 w 894042"/>
                <a:gd name="connsiteY0" fmla="*/ 396551 h 1261413"/>
                <a:gd name="connsiteX1" fmla="*/ 694415 w 894042"/>
                <a:gd name="connsiteY1" fmla="*/ 396551 h 1261413"/>
                <a:gd name="connsiteX2" fmla="*/ 717723 w 894042"/>
                <a:gd name="connsiteY2" fmla="*/ 419859 h 1261413"/>
                <a:gd name="connsiteX3" fmla="*/ 717723 w 894042"/>
                <a:gd name="connsiteY3" fmla="*/ 739003 h 1261413"/>
                <a:gd name="connsiteX4" fmla="*/ 694415 w 894042"/>
                <a:gd name="connsiteY4" fmla="*/ 762311 h 1261413"/>
                <a:gd name="connsiteX5" fmla="*/ 667879 w 894042"/>
                <a:gd name="connsiteY5" fmla="*/ 762311 h 1261413"/>
                <a:gd name="connsiteX6" fmla="*/ 644571 w 894042"/>
                <a:gd name="connsiteY6" fmla="*/ 739003 h 1261413"/>
                <a:gd name="connsiteX7" fmla="*/ 644571 w 894042"/>
                <a:gd name="connsiteY7" fmla="*/ 419859 h 1261413"/>
                <a:gd name="connsiteX8" fmla="*/ 667879 w 894042"/>
                <a:gd name="connsiteY8" fmla="*/ 396551 h 1261413"/>
                <a:gd name="connsiteX9" fmla="*/ 196721 w 894042"/>
                <a:gd name="connsiteY9" fmla="*/ 396551 h 1261413"/>
                <a:gd name="connsiteX10" fmla="*/ 223257 w 894042"/>
                <a:gd name="connsiteY10" fmla="*/ 396551 h 1261413"/>
                <a:gd name="connsiteX11" fmla="*/ 246565 w 894042"/>
                <a:gd name="connsiteY11" fmla="*/ 419859 h 1261413"/>
                <a:gd name="connsiteX12" fmla="*/ 246565 w 894042"/>
                <a:gd name="connsiteY12" fmla="*/ 739003 h 1261413"/>
                <a:gd name="connsiteX13" fmla="*/ 223257 w 894042"/>
                <a:gd name="connsiteY13" fmla="*/ 762311 h 1261413"/>
                <a:gd name="connsiteX14" fmla="*/ 196721 w 894042"/>
                <a:gd name="connsiteY14" fmla="*/ 762311 h 1261413"/>
                <a:gd name="connsiteX15" fmla="*/ 173413 w 894042"/>
                <a:gd name="connsiteY15" fmla="*/ 739003 h 1261413"/>
                <a:gd name="connsiteX16" fmla="*/ 173413 w 894042"/>
                <a:gd name="connsiteY16" fmla="*/ 419859 h 1261413"/>
                <a:gd name="connsiteX17" fmla="*/ 196721 w 894042"/>
                <a:gd name="connsiteY17" fmla="*/ 396551 h 1261413"/>
                <a:gd name="connsiteX18" fmla="*/ 298334 w 894042"/>
                <a:gd name="connsiteY18" fmla="*/ 378965 h 1261413"/>
                <a:gd name="connsiteX19" fmla="*/ 590416 w 894042"/>
                <a:gd name="connsiteY19" fmla="*/ 378965 h 1261413"/>
                <a:gd name="connsiteX20" fmla="*/ 627255 w 894042"/>
                <a:gd name="connsiteY20" fmla="*/ 415804 h 1261413"/>
                <a:gd name="connsiteX21" fmla="*/ 627255 w 894042"/>
                <a:gd name="connsiteY21" fmla="*/ 743811 h 1261413"/>
                <a:gd name="connsiteX22" fmla="*/ 627255 w 894042"/>
                <a:gd name="connsiteY22" fmla="*/ 903431 h 1261413"/>
                <a:gd name="connsiteX23" fmla="*/ 627255 w 894042"/>
                <a:gd name="connsiteY23" fmla="*/ 1217710 h 1261413"/>
                <a:gd name="connsiteX24" fmla="*/ 583552 w 894042"/>
                <a:gd name="connsiteY24" fmla="*/ 1261413 h 1261413"/>
                <a:gd name="connsiteX25" fmla="*/ 533798 w 894042"/>
                <a:gd name="connsiteY25" fmla="*/ 1261413 h 1261413"/>
                <a:gd name="connsiteX26" fmla="*/ 490095 w 894042"/>
                <a:gd name="connsiteY26" fmla="*/ 1217710 h 1261413"/>
                <a:gd name="connsiteX27" fmla="*/ 490095 w 894042"/>
                <a:gd name="connsiteY27" fmla="*/ 940270 h 1261413"/>
                <a:gd name="connsiteX28" fmla="*/ 398655 w 894042"/>
                <a:gd name="connsiteY28" fmla="*/ 940270 h 1261413"/>
                <a:gd name="connsiteX29" fmla="*/ 398655 w 894042"/>
                <a:gd name="connsiteY29" fmla="*/ 1217710 h 1261413"/>
                <a:gd name="connsiteX30" fmla="*/ 354952 w 894042"/>
                <a:gd name="connsiteY30" fmla="*/ 1261413 h 1261413"/>
                <a:gd name="connsiteX31" fmla="*/ 305198 w 894042"/>
                <a:gd name="connsiteY31" fmla="*/ 1261413 h 1261413"/>
                <a:gd name="connsiteX32" fmla="*/ 261495 w 894042"/>
                <a:gd name="connsiteY32" fmla="*/ 1217710 h 1261413"/>
                <a:gd name="connsiteX33" fmla="*/ 261495 w 894042"/>
                <a:gd name="connsiteY33" fmla="*/ 903431 h 1261413"/>
                <a:gd name="connsiteX34" fmla="*/ 261495 w 894042"/>
                <a:gd name="connsiteY34" fmla="*/ 743811 h 1261413"/>
                <a:gd name="connsiteX35" fmla="*/ 261495 w 894042"/>
                <a:gd name="connsiteY35" fmla="*/ 415804 h 1261413"/>
                <a:gd name="connsiteX36" fmla="*/ 298334 w 894042"/>
                <a:gd name="connsiteY36" fmla="*/ 378965 h 1261413"/>
                <a:gd name="connsiteX37" fmla="*/ 447021 w 894042"/>
                <a:gd name="connsiteY37" fmla="*/ 0 h 1261413"/>
                <a:gd name="connsiteX38" fmla="*/ 575308 w 894042"/>
                <a:gd name="connsiteY38" fmla="*/ 53138 h 1261413"/>
                <a:gd name="connsiteX39" fmla="*/ 612892 w 894042"/>
                <a:gd name="connsiteY39" fmla="*/ 108884 h 1261413"/>
                <a:gd name="connsiteX40" fmla="*/ 606927 w 894042"/>
                <a:gd name="connsiteY40" fmla="*/ 78298 h 1261413"/>
                <a:gd name="connsiteX41" fmla="*/ 613919 w 894042"/>
                <a:gd name="connsiteY41" fmla="*/ 55708 h 1261413"/>
                <a:gd name="connsiteX42" fmla="*/ 789734 w 894042"/>
                <a:gd name="connsiteY42" fmla="*/ 74646 h 1261413"/>
                <a:gd name="connsiteX43" fmla="*/ 894042 w 894042"/>
                <a:gd name="connsiteY43" fmla="*/ 217437 h 1261413"/>
                <a:gd name="connsiteX44" fmla="*/ 695282 w 894042"/>
                <a:gd name="connsiteY44" fmla="*/ 162957 h 1261413"/>
                <a:gd name="connsiteX45" fmla="*/ 641164 w 894042"/>
                <a:gd name="connsiteY45" fmla="*/ 147139 h 1261413"/>
                <a:gd name="connsiteX46" fmla="*/ 615110 w 894042"/>
                <a:gd name="connsiteY46" fmla="*/ 115371 h 1261413"/>
                <a:gd name="connsiteX47" fmla="*/ 628445 w 894042"/>
                <a:gd name="connsiteY47" fmla="*/ 181424 h 1261413"/>
                <a:gd name="connsiteX48" fmla="*/ 447021 w 894042"/>
                <a:gd name="connsiteY48" fmla="*/ 362848 h 1261413"/>
                <a:gd name="connsiteX49" fmla="*/ 265597 w 894042"/>
                <a:gd name="connsiteY49" fmla="*/ 181424 h 1261413"/>
                <a:gd name="connsiteX50" fmla="*/ 278933 w 894042"/>
                <a:gd name="connsiteY50" fmla="*/ 115371 h 1261413"/>
                <a:gd name="connsiteX51" fmla="*/ 252878 w 894042"/>
                <a:gd name="connsiteY51" fmla="*/ 147139 h 1261413"/>
                <a:gd name="connsiteX52" fmla="*/ 198760 w 894042"/>
                <a:gd name="connsiteY52" fmla="*/ 162957 h 1261413"/>
                <a:gd name="connsiteX53" fmla="*/ 0 w 894042"/>
                <a:gd name="connsiteY53" fmla="*/ 217437 h 1261413"/>
                <a:gd name="connsiteX54" fmla="*/ 104308 w 894042"/>
                <a:gd name="connsiteY54" fmla="*/ 74646 h 1261413"/>
                <a:gd name="connsiteX55" fmla="*/ 280123 w 894042"/>
                <a:gd name="connsiteY55" fmla="*/ 55708 h 1261413"/>
                <a:gd name="connsiteX56" fmla="*/ 287115 w 894042"/>
                <a:gd name="connsiteY56" fmla="*/ 78298 h 1261413"/>
                <a:gd name="connsiteX57" fmla="*/ 281150 w 894042"/>
                <a:gd name="connsiteY57" fmla="*/ 108884 h 1261413"/>
                <a:gd name="connsiteX58" fmla="*/ 318735 w 894042"/>
                <a:gd name="connsiteY58" fmla="*/ 53138 h 1261413"/>
                <a:gd name="connsiteX59" fmla="*/ 447021 w 894042"/>
                <a:gd name="connsiteY59" fmla="*/ 0 h 12614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</a:cxnLst>
              <a:rect l="l" t="t" r="r" b="b"/>
              <a:pathLst>
                <a:path w="894042" h="1261413">
                  <a:moveTo>
                    <a:pt x="667879" y="396551"/>
                  </a:moveTo>
                  <a:lnTo>
                    <a:pt x="694415" y="396551"/>
                  </a:lnTo>
                  <a:cubicBezTo>
                    <a:pt x="707288" y="396551"/>
                    <a:pt x="717723" y="406986"/>
                    <a:pt x="717723" y="419859"/>
                  </a:cubicBezTo>
                  <a:lnTo>
                    <a:pt x="717723" y="739003"/>
                  </a:lnTo>
                  <a:cubicBezTo>
                    <a:pt x="717723" y="751876"/>
                    <a:pt x="707288" y="762311"/>
                    <a:pt x="694415" y="762311"/>
                  </a:cubicBezTo>
                  <a:lnTo>
                    <a:pt x="667879" y="762311"/>
                  </a:lnTo>
                  <a:cubicBezTo>
                    <a:pt x="655006" y="762311"/>
                    <a:pt x="644571" y="751876"/>
                    <a:pt x="644571" y="739003"/>
                  </a:cubicBezTo>
                  <a:lnTo>
                    <a:pt x="644571" y="419859"/>
                  </a:lnTo>
                  <a:cubicBezTo>
                    <a:pt x="644571" y="406986"/>
                    <a:pt x="655006" y="396551"/>
                    <a:pt x="667879" y="396551"/>
                  </a:cubicBezTo>
                  <a:close/>
                  <a:moveTo>
                    <a:pt x="196721" y="396551"/>
                  </a:moveTo>
                  <a:lnTo>
                    <a:pt x="223257" y="396551"/>
                  </a:lnTo>
                  <a:cubicBezTo>
                    <a:pt x="236130" y="396551"/>
                    <a:pt x="246565" y="406986"/>
                    <a:pt x="246565" y="419859"/>
                  </a:cubicBezTo>
                  <a:lnTo>
                    <a:pt x="246565" y="739003"/>
                  </a:lnTo>
                  <a:cubicBezTo>
                    <a:pt x="246565" y="751876"/>
                    <a:pt x="236130" y="762311"/>
                    <a:pt x="223257" y="762311"/>
                  </a:cubicBezTo>
                  <a:lnTo>
                    <a:pt x="196721" y="762311"/>
                  </a:lnTo>
                  <a:cubicBezTo>
                    <a:pt x="183848" y="762311"/>
                    <a:pt x="173413" y="751876"/>
                    <a:pt x="173413" y="739003"/>
                  </a:cubicBezTo>
                  <a:lnTo>
                    <a:pt x="173413" y="419859"/>
                  </a:lnTo>
                  <a:cubicBezTo>
                    <a:pt x="173413" y="406986"/>
                    <a:pt x="183848" y="396551"/>
                    <a:pt x="196721" y="396551"/>
                  </a:cubicBezTo>
                  <a:close/>
                  <a:moveTo>
                    <a:pt x="298334" y="378965"/>
                  </a:moveTo>
                  <a:lnTo>
                    <a:pt x="590416" y="378965"/>
                  </a:lnTo>
                  <a:cubicBezTo>
                    <a:pt x="610762" y="378965"/>
                    <a:pt x="627255" y="395458"/>
                    <a:pt x="627255" y="415804"/>
                  </a:cubicBezTo>
                  <a:lnTo>
                    <a:pt x="627255" y="743811"/>
                  </a:lnTo>
                  <a:lnTo>
                    <a:pt x="627255" y="903431"/>
                  </a:lnTo>
                  <a:lnTo>
                    <a:pt x="627255" y="1217710"/>
                  </a:lnTo>
                  <a:cubicBezTo>
                    <a:pt x="627255" y="1241847"/>
                    <a:pt x="607689" y="1261413"/>
                    <a:pt x="583552" y="1261413"/>
                  </a:cubicBezTo>
                  <a:lnTo>
                    <a:pt x="533798" y="1261413"/>
                  </a:lnTo>
                  <a:cubicBezTo>
                    <a:pt x="509661" y="1261413"/>
                    <a:pt x="490095" y="1241847"/>
                    <a:pt x="490095" y="1217710"/>
                  </a:cubicBezTo>
                  <a:lnTo>
                    <a:pt x="490095" y="940270"/>
                  </a:lnTo>
                  <a:lnTo>
                    <a:pt x="398655" y="940270"/>
                  </a:lnTo>
                  <a:lnTo>
                    <a:pt x="398655" y="1217710"/>
                  </a:lnTo>
                  <a:cubicBezTo>
                    <a:pt x="398655" y="1241847"/>
                    <a:pt x="379089" y="1261413"/>
                    <a:pt x="354952" y="1261413"/>
                  </a:cubicBezTo>
                  <a:lnTo>
                    <a:pt x="305198" y="1261413"/>
                  </a:lnTo>
                  <a:cubicBezTo>
                    <a:pt x="281061" y="1261413"/>
                    <a:pt x="261495" y="1241847"/>
                    <a:pt x="261495" y="1217710"/>
                  </a:cubicBezTo>
                  <a:lnTo>
                    <a:pt x="261495" y="903431"/>
                  </a:lnTo>
                  <a:lnTo>
                    <a:pt x="261495" y="743811"/>
                  </a:lnTo>
                  <a:lnTo>
                    <a:pt x="261495" y="415804"/>
                  </a:lnTo>
                  <a:cubicBezTo>
                    <a:pt x="261495" y="395458"/>
                    <a:pt x="277988" y="378965"/>
                    <a:pt x="298334" y="378965"/>
                  </a:cubicBezTo>
                  <a:close/>
                  <a:moveTo>
                    <a:pt x="447021" y="0"/>
                  </a:moveTo>
                  <a:cubicBezTo>
                    <a:pt x="497120" y="0"/>
                    <a:pt x="542476" y="20307"/>
                    <a:pt x="575308" y="53138"/>
                  </a:cubicBezTo>
                  <a:lnTo>
                    <a:pt x="612892" y="108884"/>
                  </a:lnTo>
                  <a:lnTo>
                    <a:pt x="606927" y="78298"/>
                  </a:lnTo>
                  <a:cubicBezTo>
                    <a:pt x="607295" y="67763"/>
                    <a:pt x="609984" y="59387"/>
                    <a:pt x="613919" y="55708"/>
                  </a:cubicBezTo>
                  <a:cubicBezTo>
                    <a:pt x="629660" y="40990"/>
                    <a:pt x="727550" y="3709"/>
                    <a:pt x="789734" y="74646"/>
                  </a:cubicBezTo>
                  <a:cubicBezTo>
                    <a:pt x="851918" y="145582"/>
                    <a:pt x="873124" y="188423"/>
                    <a:pt x="894042" y="217437"/>
                  </a:cubicBezTo>
                  <a:cubicBezTo>
                    <a:pt x="848971" y="205166"/>
                    <a:pt x="788182" y="165634"/>
                    <a:pt x="695282" y="162957"/>
                  </a:cubicBezTo>
                  <a:cubicBezTo>
                    <a:pt x="672057" y="162287"/>
                    <a:pt x="654376" y="156169"/>
                    <a:pt x="641164" y="147139"/>
                  </a:cubicBezTo>
                  <a:lnTo>
                    <a:pt x="615110" y="115371"/>
                  </a:lnTo>
                  <a:lnTo>
                    <a:pt x="628445" y="181424"/>
                  </a:lnTo>
                  <a:cubicBezTo>
                    <a:pt x="628445" y="281622"/>
                    <a:pt x="547219" y="362848"/>
                    <a:pt x="447021" y="362848"/>
                  </a:cubicBezTo>
                  <a:cubicBezTo>
                    <a:pt x="346823" y="362848"/>
                    <a:pt x="265597" y="281622"/>
                    <a:pt x="265597" y="181424"/>
                  </a:cubicBezTo>
                  <a:lnTo>
                    <a:pt x="278933" y="115371"/>
                  </a:lnTo>
                  <a:lnTo>
                    <a:pt x="252878" y="147139"/>
                  </a:lnTo>
                  <a:cubicBezTo>
                    <a:pt x="239666" y="156169"/>
                    <a:pt x="221985" y="162287"/>
                    <a:pt x="198760" y="162957"/>
                  </a:cubicBezTo>
                  <a:cubicBezTo>
                    <a:pt x="105860" y="165634"/>
                    <a:pt x="45071" y="205166"/>
                    <a:pt x="0" y="217437"/>
                  </a:cubicBezTo>
                  <a:cubicBezTo>
                    <a:pt x="20918" y="188423"/>
                    <a:pt x="42124" y="145582"/>
                    <a:pt x="104308" y="74646"/>
                  </a:cubicBezTo>
                  <a:cubicBezTo>
                    <a:pt x="166492" y="3709"/>
                    <a:pt x="264382" y="40990"/>
                    <a:pt x="280123" y="55708"/>
                  </a:cubicBezTo>
                  <a:cubicBezTo>
                    <a:pt x="284059" y="59387"/>
                    <a:pt x="286747" y="67763"/>
                    <a:pt x="287115" y="78298"/>
                  </a:cubicBezTo>
                  <a:lnTo>
                    <a:pt x="281150" y="108884"/>
                  </a:lnTo>
                  <a:lnTo>
                    <a:pt x="318735" y="53138"/>
                  </a:lnTo>
                  <a:cubicBezTo>
                    <a:pt x="351566" y="20307"/>
                    <a:pt x="396922" y="0"/>
                    <a:pt x="447021" y="0"/>
                  </a:cubicBezTo>
                  <a:close/>
                </a:path>
              </a:pathLst>
            </a:custGeom>
            <a:solidFill>
              <a:srgbClr val="FF66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de-DE" sz="1500"/>
            </a:p>
          </p:txBody>
        </p:sp>
        <p:sp>
          <p:nvSpPr>
            <p:cNvPr id="13" name="Freeform 12"/>
            <p:cNvSpPr>
              <a:spLocks noChangeAspect="1"/>
            </p:cNvSpPr>
            <p:nvPr/>
          </p:nvSpPr>
          <p:spPr>
            <a:xfrm>
              <a:off x="799630" y="2608627"/>
              <a:ext cx="259864" cy="667365"/>
            </a:xfrm>
            <a:custGeom>
              <a:avLst/>
              <a:gdLst>
                <a:gd name="connsiteX0" fmla="*/ 494466 w 544310"/>
                <a:gd name="connsiteY0" fmla="*/ 408452 h 1267452"/>
                <a:gd name="connsiteX1" fmla="*/ 521002 w 544310"/>
                <a:gd name="connsiteY1" fmla="*/ 408452 h 1267452"/>
                <a:gd name="connsiteX2" fmla="*/ 544310 w 544310"/>
                <a:gd name="connsiteY2" fmla="*/ 431760 h 1267452"/>
                <a:gd name="connsiteX3" fmla="*/ 544310 w 544310"/>
                <a:gd name="connsiteY3" fmla="*/ 750904 h 1267452"/>
                <a:gd name="connsiteX4" fmla="*/ 521002 w 544310"/>
                <a:gd name="connsiteY4" fmla="*/ 774212 h 1267452"/>
                <a:gd name="connsiteX5" fmla="*/ 494466 w 544310"/>
                <a:gd name="connsiteY5" fmla="*/ 774212 h 1267452"/>
                <a:gd name="connsiteX6" fmla="*/ 471158 w 544310"/>
                <a:gd name="connsiteY6" fmla="*/ 750904 h 1267452"/>
                <a:gd name="connsiteX7" fmla="*/ 471158 w 544310"/>
                <a:gd name="connsiteY7" fmla="*/ 431760 h 1267452"/>
                <a:gd name="connsiteX8" fmla="*/ 494466 w 544310"/>
                <a:gd name="connsiteY8" fmla="*/ 408452 h 1267452"/>
                <a:gd name="connsiteX9" fmla="*/ 23308 w 544310"/>
                <a:gd name="connsiteY9" fmla="*/ 408452 h 1267452"/>
                <a:gd name="connsiteX10" fmla="*/ 49844 w 544310"/>
                <a:gd name="connsiteY10" fmla="*/ 408452 h 1267452"/>
                <a:gd name="connsiteX11" fmla="*/ 73152 w 544310"/>
                <a:gd name="connsiteY11" fmla="*/ 431760 h 1267452"/>
                <a:gd name="connsiteX12" fmla="*/ 73152 w 544310"/>
                <a:gd name="connsiteY12" fmla="*/ 750904 h 1267452"/>
                <a:gd name="connsiteX13" fmla="*/ 49844 w 544310"/>
                <a:gd name="connsiteY13" fmla="*/ 774212 h 1267452"/>
                <a:gd name="connsiteX14" fmla="*/ 23308 w 544310"/>
                <a:gd name="connsiteY14" fmla="*/ 774212 h 1267452"/>
                <a:gd name="connsiteX15" fmla="*/ 0 w 544310"/>
                <a:gd name="connsiteY15" fmla="*/ 750904 h 1267452"/>
                <a:gd name="connsiteX16" fmla="*/ 0 w 544310"/>
                <a:gd name="connsiteY16" fmla="*/ 431760 h 1267452"/>
                <a:gd name="connsiteX17" fmla="*/ 23308 w 544310"/>
                <a:gd name="connsiteY17" fmla="*/ 408452 h 1267452"/>
                <a:gd name="connsiteX18" fmla="*/ 124921 w 544310"/>
                <a:gd name="connsiteY18" fmla="*/ 385004 h 1267452"/>
                <a:gd name="connsiteX19" fmla="*/ 417003 w 544310"/>
                <a:gd name="connsiteY19" fmla="*/ 385004 h 1267452"/>
                <a:gd name="connsiteX20" fmla="*/ 453842 w 544310"/>
                <a:gd name="connsiteY20" fmla="*/ 421843 h 1267452"/>
                <a:gd name="connsiteX21" fmla="*/ 453842 w 544310"/>
                <a:gd name="connsiteY21" fmla="*/ 749850 h 1267452"/>
                <a:gd name="connsiteX22" fmla="*/ 453842 w 544310"/>
                <a:gd name="connsiteY22" fmla="*/ 909470 h 1267452"/>
                <a:gd name="connsiteX23" fmla="*/ 453842 w 544310"/>
                <a:gd name="connsiteY23" fmla="*/ 1223749 h 1267452"/>
                <a:gd name="connsiteX24" fmla="*/ 410139 w 544310"/>
                <a:gd name="connsiteY24" fmla="*/ 1267452 h 1267452"/>
                <a:gd name="connsiteX25" fmla="*/ 360385 w 544310"/>
                <a:gd name="connsiteY25" fmla="*/ 1267452 h 1267452"/>
                <a:gd name="connsiteX26" fmla="*/ 316682 w 544310"/>
                <a:gd name="connsiteY26" fmla="*/ 1223749 h 1267452"/>
                <a:gd name="connsiteX27" fmla="*/ 316682 w 544310"/>
                <a:gd name="connsiteY27" fmla="*/ 946309 h 1267452"/>
                <a:gd name="connsiteX28" fmla="*/ 225242 w 544310"/>
                <a:gd name="connsiteY28" fmla="*/ 946309 h 1267452"/>
                <a:gd name="connsiteX29" fmla="*/ 225242 w 544310"/>
                <a:gd name="connsiteY29" fmla="*/ 1223749 h 1267452"/>
                <a:gd name="connsiteX30" fmla="*/ 181539 w 544310"/>
                <a:gd name="connsiteY30" fmla="*/ 1267452 h 1267452"/>
                <a:gd name="connsiteX31" fmla="*/ 131785 w 544310"/>
                <a:gd name="connsiteY31" fmla="*/ 1267452 h 1267452"/>
                <a:gd name="connsiteX32" fmla="*/ 88082 w 544310"/>
                <a:gd name="connsiteY32" fmla="*/ 1223749 h 1267452"/>
                <a:gd name="connsiteX33" fmla="*/ 88082 w 544310"/>
                <a:gd name="connsiteY33" fmla="*/ 909470 h 1267452"/>
                <a:gd name="connsiteX34" fmla="*/ 88082 w 544310"/>
                <a:gd name="connsiteY34" fmla="*/ 749850 h 1267452"/>
                <a:gd name="connsiteX35" fmla="*/ 88082 w 544310"/>
                <a:gd name="connsiteY35" fmla="*/ 421843 h 1267452"/>
                <a:gd name="connsiteX36" fmla="*/ 124921 w 544310"/>
                <a:gd name="connsiteY36" fmla="*/ 385004 h 1267452"/>
                <a:gd name="connsiteX37" fmla="*/ 272155 w 544310"/>
                <a:gd name="connsiteY37" fmla="*/ 0 h 1267452"/>
                <a:gd name="connsiteX38" fmla="*/ 453579 w 544310"/>
                <a:gd name="connsiteY38" fmla="*/ 181424 h 1267452"/>
                <a:gd name="connsiteX39" fmla="*/ 272155 w 544310"/>
                <a:gd name="connsiteY39" fmla="*/ 362848 h 1267452"/>
                <a:gd name="connsiteX40" fmla="*/ 90731 w 544310"/>
                <a:gd name="connsiteY40" fmla="*/ 181424 h 1267452"/>
                <a:gd name="connsiteX41" fmla="*/ 272155 w 544310"/>
                <a:gd name="connsiteY41" fmla="*/ 0 h 12674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</a:cxnLst>
              <a:rect l="l" t="t" r="r" b="b"/>
              <a:pathLst>
                <a:path w="544310" h="1267452">
                  <a:moveTo>
                    <a:pt x="494466" y="408452"/>
                  </a:moveTo>
                  <a:lnTo>
                    <a:pt x="521002" y="408452"/>
                  </a:lnTo>
                  <a:cubicBezTo>
                    <a:pt x="533875" y="408452"/>
                    <a:pt x="544310" y="418887"/>
                    <a:pt x="544310" y="431760"/>
                  </a:cubicBezTo>
                  <a:lnTo>
                    <a:pt x="544310" y="750904"/>
                  </a:lnTo>
                  <a:cubicBezTo>
                    <a:pt x="544310" y="763777"/>
                    <a:pt x="533875" y="774212"/>
                    <a:pt x="521002" y="774212"/>
                  </a:cubicBezTo>
                  <a:lnTo>
                    <a:pt x="494466" y="774212"/>
                  </a:lnTo>
                  <a:cubicBezTo>
                    <a:pt x="481593" y="774212"/>
                    <a:pt x="471158" y="763777"/>
                    <a:pt x="471158" y="750904"/>
                  </a:cubicBezTo>
                  <a:lnTo>
                    <a:pt x="471158" y="431760"/>
                  </a:lnTo>
                  <a:cubicBezTo>
                    <a:pt x="471158" y="418887"/>
                    <a:pt x="481593" y="408452"/>
                    <a:pt x="494466" y="408452"/>
                  </a:cubicBezTo>
                  <a:close/>
                  <a:moveTo>
                    <a:pt x="23308" y="408452"/>
                  </a:moveTo>
                  <a:lnTo>
                    <a:pt x="49844" y="408452"/>
                  </a:lnTo>
                  <a:cubicBezTo>
                    <a:pt x="62717" y="408452"/>
                    <a:pt x="73152" y="418887"/>
                    <a:pt x="73152" y="431760"/>
                  </a:cubicBezTo>
                  <a:lnTo>
                    <a:pt x="73152" y="750904"/>
                  </a:lnTo>
                  <a:cubicBezTo>
                    <a:pt x="73152" y="763777"/>
                    <a:pt x="62717" y="774212"/>
                    <a:pt x="49844" y="774212"/>
                  </a:cubicBezTo>
                  <a:lnTo>
                    <a:pt x="23308" y="774212"/>
                  </a:lnTo>
                  <a:cubicBezTo>
                    <a:pt x="10435" y="774212"/>
                    <a:pt x="0" y="763777"/>
                    <a:pt x="0" y="750904"/>
                  </a:cubicBezTo>
                  <a:lnTo>
                    <a:pt x="0" y="431760"/>
                  </a:lnTo>
                  <a:cubicBezTo>
                    <a:pt x="0" y="418887"/>
                    <a:pt x="10435" y="408452"/>
                    <a:pt x="23308" y="408452"/>
                  </a:cubicBezTo>
                  <a:close/>
                  <a:moveTo>
                    <a:pt x="124921" y="385004"/>
                  </a:moveTo>
                  <a:lnTo>
                    <a:pt x="417003" y="385004"/>
                  </a:lnTo>
                  <a:cubicBezTo>
                    <a:pt x="437349" y="385004"/>
                    <a:pt x="453842" y="401497"/>
                    <a:pt x="453842" y="421843"/>
                  </a:cubicBezTo>
                  <a:lnTo>
                    <a:pt x="453842" y="749850"/>
                  </a:lnTo>
                  <a:lnTo>
                    <a:pt x="453842" y="909470"/>
                  </a:lnTo>
                  <a:lnTo>
                    <a:pt x="453842" y="1223749"/>
                  </a:lnTo>
                  <a:cubicBezTo>
                    <a:pt x="453842" y="1247886"/>
                    <a:pt x="434276" y="1267452"/>
                    <a:pt x="410139" y="1267452"/>
                  </a:cubicBezTo>
                  <a:lnTo>
                    <a:pt x="360385" y="1267452"/>
                  </a:lnTo>
                  <a:cubicBezTo>
                    <a:pt x="336248" y="1267452"/>
                    <a:pt x="316682" y="1247886"/>
                    <a:pt x="316682" y="1223749"/>
                  </a:cubicBezTo>
                  <a:lnTo>
                    <a:pt x="316682" y="946309"/>
                  </a:lnTo>
                  <a:lnTo>
                    <a:pt x="225242" y="946309"/>
                  </a:lnTo>
                  <a:lnTo>
                    <a:pt x="225242" y="1223749"/>
                  </a:lnTo>
                  <a:cubicBezTo>
                    <a:pt x="225242" y="1247886"/>
                    <a:pt x="205676" y="1267452"/>
                    <a:pt x="181539" y="1267452"/>
                  </a:cubicBezTo>
                  <a:lnTo>
                    <a:pt x="131785" y="1267452"/>
                  </a:lnTo>
                  <a:cubicBezTo>
                    <a:pt x="107648" y="1267452"/>
                    <a:pt x="88082" y="1247886"/>
                    <a:pt x="88082" y="1223749"/>
                  </a:cubicBezTo>
                  <a:lnTo>
                    <a:pt x="88082" y="909470"/>
                  </a:lnTo>
                  <a:lnTo>
                    <a:pt x="88082" y="749850"/>
                  </a:lnTo>
                  <a:lnTo>
                    <a:pt x="88082" y="421843"/>
                  </a:lnTo>
                  <a:cubicBezTo>
                    <a:pt x="88082" y="401497"/>
                    <a:pt x="104575" y="385004"/>
                    <a:pt x="124921" y="385004"/>
                  </a:cubicBezTo>
                  <a:close/>
                  <a:moveTo>
                    <a:pt x="272155" y="0"/>
                  </a:moveTo>
                  <a:cubicBezTo>
                    <a:pt x="372353" y="0"/>
                    <a:pt x="453579" y="81226"/>
                    <a:pt x="453579" y="181424"/>
                  </a:cubicBezTo>
                  <a:cubicBezTo>
                    <a:pt x="453579" y="281622"/>
                    <a:pt x="372353" y="362848"/>
                    <a:pt x="272155" y="362848"/>
                  </a:cubicBezTo>
                  <a:cubicBezTo>
                    <a:pt x="171957" y="362848"/>
                    <a:pt x="90731" y="281622"/>
                    <a:pt x="90731" y="181424"/>
                  </a:cubicBezTo>
                  <a:cubicBezTo>
                    <a:pt x="90731" y="81226"/>
                    <a:pt x="171957" y="0"/>
                    <a:pt x="272155" y="0"/>
                  </a:cubicBezTo>
                  <a:close/>
                </a:path>
              </a:pathLst>
            </a:cu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de-DE" sz="1500"/>
            </a:p>
          </p:txBody>
        </p:sp>
      </p:grpSp>
      <p:sp>
        <p:nvSpPr>
          <p:cNvPr id="17" name="Rectangle 16"/>
          <p:cNvSpPr/>
          <p:nvPr/>
        </p:nvSpPr>
        <p:spPr>
          <a:xfrm>
            <a:off x="173448" y="1935517"/>
            <a:ext cx="4640620" cy="112951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296DC0"/>
                </a:solidFill>
              </a:rPr>
              <a:t>Prospective longitudinal stud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296DC0"/>
                </a:solidFill>
              </a:rPr>
              <a:t>≥ 2.5 years after kidney transplantation (KTx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296DC0"/>
                </a:solidFill>
              </a:rPr>
              <a:t>≥ 2 follow-up visi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296DC0"/>
                </a:solidFill>
              </a:rPr>
              <a:t>Standardized cardiovascular assessmen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952304" y="3194332"/>
            <a:ext cx="2180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296DC0"/>
                </a:solidFill>
              </a:rPr>
              <a:t>Children N = 70</a:t>
            </a:r>
          </a:p>
          <a:p>
            <a:r>
              <a:rPr lang="de-DE" dirty="0">
                <a:solidFill>
                  <a:srgbClr val="296DC0"/>
                </a:solidFill>
              </a:rPr>
              <a:t>Observations N = 211</a:t>
            </a:r>
            <a:endParaRPr lang="en-US" dirty="0">
              <a:solidFill>
                <a:srgbClr val="296DC0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93680" y="3916295"/>
            <a:ext cx="4620388" cy="44012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Endpoint: </a:t>
            </a:r>
            <a:r>
              <a:rPr lang="en-GB" b="1" dirty="0"/>
              <a:t>Pulse Wave Velocity (PWV) </a:t>
            </a:r>
            <a:r>
              <a:rPr lang="en-GB" dirty="0"/>
              <a:t>z-score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93680" y="4403312"/>
            <a:ext cx="2315058" cy="106680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redictor:</a:t>
            </a:r>
          </a:p>
          <a:p>
            <a:pPr algn="ctr"/>
            <a:r>
              <a:rPr lang="en-GB" dirty="0"/>
              <a:t>BP changes (∆ systolic &amp; diastolic BP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2590099" y="4424124"/>
            <a:ext cx="2187928" cy="300793"/>
          </a:xfrm>
          <a:prstGeom prst="rect">
            <a:avLst/>
          </a:prstGeom>
          <a:noFill/>
          <a:ln w="12700">
            <a:solidFill>
              <a:srgbClr val="00B05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Stable/decreasing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590099" y="4804350"/>
            <a:ext cx="2187928" cy="300793"/>
          </a:xfrm>
          <a:prstGeom prst="rect">
            <a:avLst/>
          </a:prstGeom>
          <a:noFill/>
          <a:ln w="12700">
            <a:solidFill>
              <a:schemeClr val="accent4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Increase 1-10 mmHg</a:t>
            </a:r>
          </a:p>
        </p:txBody>
      </p:sp>
      <p:sp>
        <p:nvSpPr>
          <p:cNvPr id="29" name="Rectangle 28"/>
          <p:cNvSpPr/>
          <p:nvPr/>
        </p:nvSpPr>
        <p:spPr>
          <a:xfrm>
            <a:off x="2590099" y="5169323"/>
            <a:ext cx="2187928" cy="300793"/>
          </a:xfrm>
          <a:prstGeom prst="rect">
            <a:avLst/>
          </a:prstGeom>
          <a:noFill/>
          <a:ln w="12700">
            <a:solidFill>
              <a:srgbClr val="FF00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Increase &gt; 10mmHg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41115" y="1673019"/>
            <a:ext cx="6858442" cy="38721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106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8</cp:revision>
  <cp:lastPrinted>2021-07-01T10:55:39Z</cp:lastPrinted>
  <dcterms:created xsi:type="dcterms:W3CDTF">2019-06-13T12:30:18Z</dcterms:created>
  <dcterms:modified xsi:type="dcterms:W3CDTF">2022-05-04T19:13:54Z</dcterms:modified>
</cp:coreProperties>
</file>